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8F54638-B0DE-46FC-A4C4-7A3403CEC2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1726EE6-E548-4E97-9F6F-426A4CD67B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1EB7942-5503-4865-AFF4-63D683D0C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1E6944B-98EC-4E64-9B39-C5C151888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C3CD6E7-D644-4B3F-AA60-F908C0EC9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1697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851376-AC6D-42E7-91C3-868EFCCB3E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5F3F02A-E408-46B8-84DE-0D62616C53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08ED5A8-7A8C-4185-9458-9991AE444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5D7CB57-1821-4A5B-96A0-0BE9F67D9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B277D18-3D2E-46A0-8DE3-716398FD9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5943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B4A6A5FF-8EF2-4378-9059-0E9ACE4A53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44B112B-81CD-4C67-8C64-56BE5DE90F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177ACF6-7DCE-4A7F-A69D-32AEC8F38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1DCFE17-5D0E-46A0-AB92-FA7A940EE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A99A74F-302B-472B-8DCA-0CE09DEEE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765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2913BD7-9F3D-4180-A641-EC99B48940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2A097BA-3799-46BD-95E6-7AD2849933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739B341-E57F-4930-BC4D-795EA2061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1A3C910-2319-4046-ACE7-A9D6254B0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E748E2-0DF9-4F7F-9243-0DEA3826E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468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E7AF777-C9AC-4997-AA6C-9C3CDEB091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D364F93-2EA2-4E78-A1FF-E4BFAD77B7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E24DCD5-7010-4BD3-939D-83AC60E29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BF4C4AB-B3D8-4606-AE46-10CE0846B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4B8AB8F-0731-4D41-A6CB-5ADBAF7FE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6470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59A6B2-EE2F-4249-95AA-DD78206CCB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E085B3C-A126-429B-BEB0-D7EF747E28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E95E5B6-E1D4-46C8-807E-EE5165035A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A27B35B-0452-4BCA-9A8F-EF70AFA18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6FA2867-B804-4DC6-9EFB-EACBEF7DB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766DCA5-A41D-475F-8AA3-CA53C2358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7559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2608F4B-3B4B-4224-9281-194A6AECE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743B62E-C417-45CA-8C1A-553915454C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54FAF4B-E630-4938-AE62-91E906E1C1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2237940-714E-4424-B4BB-D90E985F03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97F3021-8F9B-4F3C-A7BF-0D4348E09B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C3917500-1275-4C41-BC77-CC554E3D4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6BB5974-4917-4A77-B485-2BC0B850A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4B0BADA-BA75-411A-9F29-4797F8CFD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7829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3CDFE86-77FB-491A-B64E-D8293BC09E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4169DE58-B09C-4022-986E-A95B50C04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117D388-F3CB-4243-9F86-6A7AF7D31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B024DAA-0E21-4998-B14F-FED430665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4935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A637DC5-532B-4F00-9DD6-851344C6F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865FF5F-AFE7-4D14-8F61-87A922417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01A8FA2-A3DE-471D-B007-DB3FCAF87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2881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3D56441-940D-41A1-B5DD-E390CC1F63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EC35651-B2D7-4003-A675-78B0C849A9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6779868-F07A-4FDD-AC42-0DCF15914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7F9EEAE-9EEA-4131-BE5D-BB57CC772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2029FD8-964E-4D70-800E-07114247F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5D99B1E-8FA0-4BAF-807A-BB223DB8E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6241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D78DBC-C5A0-46CC-8900-C270D1A42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FC47DAE-A316-4683-BE3B-5462A9C936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112AB42-26EA-4886-BFF4-C1E2A005C6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2440890-27CC-4A8B-8E8E-58FEB251B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2CD48AA-C815-4525-8532-3D14683FE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72E2D61-0702-4C65-BA8E-D192A7A1F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5756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87FADD8-8121-4B24-8918-54BB501C4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D58F6F3-F6B6-43EA-B863-AF4D76DBEC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0B2633B-4AD7-4356-96E7-049E24F559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AAC0011-A8C4-47AC-AD00-ABFE4FF064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831B647-A2D7-4AEA-9BC3-EB0C399141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5956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5FCF9DE6-669B-4922-9F70-1FD63607F2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1702783"/>
              </p:ext>
            </p:extLst>
          </p:nvPr>
        </p:nvGraphicFramePr>
        <p:xfrm>
          <a:off x="478172" y="1008697"/>
          <a:ext cx="10739535" cy="291356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7078">
                  <a:extLst>
                    <a:ext uri="{9D8B030D-6E8A-4147-A177-3AD203B41FA5}">
                      <a16:colId xmlns:a16="http://schemas.microsoft.com/office/drawing/2014/main" val="1268901508"/>
                    </a:ext>
                  </a:extLst>
                </a:gridCol>
                <a:gridCol w="867747">
                  <a:extLst>
                    <a:ext uri="{9D8B030D-6E8A-4147-A177-3AD203B41FA5}">
                      <a16:colId xmlns:a16="http://schemas.microsoft.com/office/drawing/2014/main" val="3512580860"/>
                    </a:ext>
                  </a:extLst>
                </a:gridCol>
                <a:gridCol w="821093">
                  <a:extLst>
                    <a:ext uri="{9D8B030D-6E8A-4147-A177-3AD203B41FA5}">
                      <a16:colId xmlns:a16="http://schemas.microsoft.com/office/drawing/2014/main" val="476996448"/>
                    </a:ext>
                  </a:extLst>
                </a:gridCol>
                <a:gridCol w="858417">
                  <a:extLst>
                    <a:ext uri="{9D8B030D-6E8A-4147-A177-3AD203B41FA5}">
                      <a16:colId xmlns:a16="http://schemas.microsoft.com/office/drawing/2014/main" val="3328747081"/>
                    </a:ext>
                  </a:extLst>
                </a:gridCol>
                <a:gridCol w="727787">
                  <a:extLst>
                    <a:ext uri="{9D8B030D-6E8A-4147-A177-3AD203B41FA5}">
                      <a16:colId xmlns:a16="http://schemas.microsoft.com/office/drawing/2014/main" val="421779997"/>
                    </a:ext>
                  </a:extLst>
                </a:gridCol>
                <a:gridCol w="874767">
                  <a:extLst>
                    <a:ext uri="{9D8B030D-6E8A-4147-A177-3AD203B41FA5}">
                      <a16:colId xmlns:a16="http://schemas.microsoft.com/office/drawing/2014/main" val="411211503"/>
                    </a:ext>
                  </a:extLst>
                </a:gridCol>
                <a:gridCol w="795413">
                  <a:extLst>
                    <a:ext uri="{9D8B030D-6E8A-4147-A177-3AD203B41FA5}">
                      <a16:colId xmlns:a16="http://schemas.microsoft.com/office/drawing/2014/main" val="3132006451"/>
                    </a:ext>
                  </a:extLst>
                </a:gridCol>
                <a:gridCol w="821094">
                  <a:extLst>
                    <a:ext uri="{9D8B030D-6E8A-4147-A177-3AD203B41FA5}">
                      <a16:colId xmlns:a16="http://schemas.microsoft.com/office/drawing/2014/main" val="3018715610"/>
                    </a:ext>
                  </a:extLst>
                </a:gridCol>
                <a:gridCol w="755780">
                  <a:extLst>
                    <a:ext uri="{9D8B030D-6E8A-4147-A177-3AD203B41FA5}">
                      <a16:colId xmlns:a16="http://schemas.microsoft.com/office/drawing/2014/main" val="2764058636"/>
                    </a:ext>
                  </a:extLst>
                </a:gridCol>
                <a:gridCol w="830424">
                  <a:extLst>
                    <a:ext uri="{9D8B030D-6E8A-4147-A177-3AD203B41FA5}">
                      <a16:colId xmlns:a16="http://schemas.microsoft.com/office/drawing/2014/main" val="1515682774"/>
                    </a:ext>
                  </a:extLst>
                </a:gridCol>
                <a:gridCol w="793102">
                  <a:extLst>
                    <a:ext uri="{9D8B030D-6E8A-4147-A177-3AD203B41FA5}">
                      <a16:colId xmlns:a16="http://schemas.microsoft.com/office/drawing/2014/main" val="128937354"/>
                    </a:ext>
                  </a:extLst>
                </a:gridCol>
                <a:gridCol w="895739">
                  <a:extLst>
                    <a:ext uri="{9D8B030D-6E8A-4147-A177-3AD203B41FA5}">
                      <a16:colId xmlns:a16="http://schemas.microsoft.com/office/drawing/2014/main" val="2056901738"/>
                    </a:ext>
                  </a:extLst>
                </a:gridCol>
                <a:gridCol w="821094">
                  <a:extLst>
                    <a:ext uri="{9D8B030D-6E8A-4147-A177-3AD203B41FA5}">
                      <a16:colId xmlns:a16="http://schemas.microsoft.com/office/drawing/2014/main" val="3608432180"/>
                    </a:ext>
                  </a:extLst>
                </a:gridCol>
              </a:tblGrid>
              <a:tr h="50198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</a:t>
                      </a: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</a:rPr>
                        <a:t>mean dose contr. Breast without CBCT</a:t>
                      </a:r>
                      <a:r>
                        <a:rPr lang="de-DE" sz="1100" u="none" strike="noStrike" dirty="0">
                          <a:effectLst/>
                        </a:rPr>
                        <a:t> 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contr. Breast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s without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s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 </a:t>
                      </a:r>
                      <a:r>
                        <a:rPr lang="en-US" sz="1100" u="none" strike="noStrike" dirty="0" err="1">
                          <a:effectLst/>
                        </a:rPr>
                        <a:t>ipsil</a:t>
                      </a:r>
                      <a:r>
                        <a:rPr lang="en-US" sz="1100" u="none" strike="noStrike" dirty="0">
                          <a:effectLst/>
                        </a:rPr>
                        <a:t>. without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 </a:t>
                      </a:r>
                      <a:r>
                        <a:rPr lang="en-US" sz="1100" u="none" strike="noStrike" dirty="0" err="1">
                          <a:effectLst/>
                        </a:rPr>
                        <a:t>ipsil</a:t>
                      </a:r>
                      <a:r>
                        <a:rPr lang="en-US" sz="1100" u="none" strike="noStrike" dirty="0">
                          <a:effectLst/>
                        </a:rPr>
                        <a:t>.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 contr. without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 contr.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thyroid without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thyroid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</a:t>
                      </a:r>
                      <a:r>
                        <a:rPr lang="en-US" sz="1100" u="none" strike="noStrike" dirty="0" err="1">
                          <a:effectLst/>
                        </a:rPr>
                        <a:t>oesophagus</a:t>
                      </a:r>
                      <a:r>
                        <a:rPr lang="en-US" sz="1100" u="none" strike="noStrike" dirty="0">
                          <a:effectLst/>
                        </a:rPr>
                        <a:t> without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</a:t>
                      </a:r>
                      <a:r>
                        <a:rPr lang="en-US" sz="1100" u="none" strike="noStrike" dirty="0" err="1">
                          <a:effectLst/>
                        </a:rPr>
                        <a:t>oesophagus</a:t>
                      </a:r>
                      <a:r>
                        <a:rPr lang="en-US" sz="1100" u="none" strike="noStrike" dirty="0">
                          <a:effectLst/>
                        </a:rPr>
                        <a:t>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1031606578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1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1,1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7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5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9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5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3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5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0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2491379721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2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0,5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8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5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0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8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4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5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7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1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2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7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0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3625271051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3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8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1,3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2,0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4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3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8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8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1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4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7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1420126498"/>
                  </a:ext>
                </a:extLst>
              </a:tr>
              <a:tr h="182394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4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9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6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5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2,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1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8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5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8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0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4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6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0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1974752891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5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0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5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9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3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2,8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3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9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1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9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9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1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1969812409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6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0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6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4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8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6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4,1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9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2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1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9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4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8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1161333276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7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4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8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5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1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9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2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6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0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8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2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8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409035115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8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7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4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6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1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3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9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0,5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9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7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4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9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1187581624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9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6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4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5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1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5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2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4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0,8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0,2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3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1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1527258637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10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8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1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4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9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5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4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8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0,0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0,1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3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7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67637367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11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9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1,1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2,03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2,6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1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3,9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4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0,3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0,5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1,1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1,6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2847734277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8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3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8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3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7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,0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60703127"/>
                  </a:ext>
                </a:extLst>
              </a:tr>
              <a:tr h="184917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4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12833641"/>
                  </a:ext>
                </a:extLst>
              </a:tr>
            </a:tbl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B9FCA881-B2C9-4FF2-B0D2-C6A14732F5B5}"/>
              </a:ext>
            </a:extLst>
          </p:cNvPr>
          <p:cNvSpPr txBox="1"/>
          <p:nvPr/>
        </p:nvSpPr>
        <p:spPr>
          <a:xfrm>
            <a:off x="478172" y="5693813"/>
            <a:ext cx="336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Table 3 </a:t>
            </a:r>
            <a:r>
              <a:rPr lang="de-DE" dirty="0" err="1"/>
              <a:t>supplementary</a:t>
            </a:r>
            <a:r>
              <a:rPr lang="de-DE" dirty="0"/>
              <a:t> material</a:t>
            </a:r>
          </a:p>
        </p:txBody>
      </p:sp>
    </p:spTree>
    <p:extLst>
      <p:ext uri="{BB962C8B-B14F-4D97-AF65-F5344CB8AC3E}">
        <p14:creationId xmlns:p14="http://schemas.microsoft.com/office/powerpoint/2010/main" val="4289456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7</Words>
  <Application>Microsoft Office PowerPoint</Application>
  <PresentationFormat>Breitbild</PresentationFormat>
  <Paragraphs>18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Chiara De-Colle</dc:creator>
  <cp:lastModifiedBy>Sabine König</cp:lastModifiedBy>
  <cp:revision>21</cp:revision>
  <dcterms:created xsi:type="dcterms:W3CDTF">2021-07-13T16:18:21Z</dcterms:created>
  <dcterms:modified xsi:type="dcterms:W3CDTF">2022-03-14T10:03:57Z</dcterms:modified>
</cp:coreProperties>
</file>